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009200" cy="929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970440" y="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3240" rIns="93240" tIns="46440" bIns="4644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txBody>
          <a:bodyPr lIns="93240" rIns="93240" tIns="46440" bIns="4644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EC2C7B-9598-4809-AEC8-881E9D184FEF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8" name="PlaceHolder 1"/>
          <p:cNvSpPr>
            <a:spLocks noGrp="1"/>
          </p:cNvSpPr>
          <p:nvPr>
            <p:ph type="sldImg"/>
          </p:nvPr>
        </p:nvSpPr>
        <p:spPr>
          <a:xfrm>
            <a:off x="1181160" y="696960"/>
            <a:ext cx="4648320" cy="3486240"/>
          </a:xfrm>
          <a:prstGeom prst="rect">
            <a:avLst/>
          </a:prstGeom>
          <a:ln w="0">
            <a:noFill/>
          </a:ln>
        </p:spPr>
      </p:sp>
      <p:sp>
        <p:nvSpPr>
          <p:cNvPr id="79" name="PlaceHolder 2"/>
          <p:cNvSpPr>
            <a:spLocks noGrp="1"/>
          </p:cNvSpPr>
          <p:nvPr>
            <p:ph type="body"/>
          </p:nvPr>
        </p:nvSpPr>
        <p:spPr>
          <a:xfrm>
            <a:off x="701280" y="4416120"/>
            <a:ext cx="5607000" cy="41828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Slide Number Placeholder 3"/>
          <p:cNvSpPr/>
          <p:nvPr/>
        </p:nvSpPr>
        <p:spPr>
          <a:xfrm>
            <a:off x="3970440" y="8829720"/>
            <a:ext cx="3038400" cy="465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3240" rIns="93240" tIns="46440" bIns="4644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924AC63-D515-4423-9E90-D182D03AAEFA}" type="slidenum">
              <a:rPr b="0" lang="en-US" sz="1200" spc="-1" strike="noStrike">
                <a:solidFill>
                  <a:srgbClr val="000000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77DC67-90FF-4F6B-BE4E-388ED009389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1F65A-2A32-4D0E-B313-0E01D174B4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81A3360-863E-4F7C-BECE-6B495920814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C717F9-D1A6-40A8-8F0B-446EF988B9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81F9B5-953E-483D-B541-A260C7EED0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761701-18E8-4412-B3F4-3DA8521733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DC1121-3E18-4CE3-A409-AAA1357ED59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BFD1FE-02EE-423B-A57F-629FE54EC7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BC2E74-60F7-4DF2-902E-F2E5ED0B2A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2BE8F1-0240-4CDF-94FA-5637F0CB17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AEBBF1-7A56-424F-BFDE-789AA2251F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C1F4EF-A6B6-437C-87AC-0A30E4A2987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Times New Roman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085FB2F-B106-44FC-9F07-2C9EEA325086}" type="slidenum">
              <a:rPr b="0" lang="en-US" sz="1200" spc="-1" strike="noStrike">
                <a:solidFill>
                  <a:srgbClr val="898989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37"/>
          <p:cNvSpPr/>
          <p:nvPr/>
        </p:nvSpPr>
        <p:spPr>
          <a:xfrm>
            <a:off x="1689120" y="4726080"/>
            <a:ext cx="5931000" cy="1554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3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: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FITM1 promoter sequence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IFITM1 promoter has multiple consensus sequences that provide alternative binding sites for the STATs complexes. These include: Interferon stimulated response element (ISRE) – GGAAATAGAAACT, gamma activated site (GAS)– TTCNNNGAA, interferon regulatory factors (IRFs): AANNGAAA, half palindromes: TTC, half-sites: TTA. The half sites and half palindromes are STAT1 binding sites. ISRE and IRF sequences greatly overlap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Rectangle 1"/>
          <p:cNvSpPr/>
          <p:nvPr/>
        </p:nvSpPr>
        <p:spPr>
          <a:xfrm>
            <a:off x="2021400" y="530280"/>
            <a:ext cx="5648760" cy="4109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A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GATCCTTGTGCCTGAGGGCTCCC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GCTACTCAGTCTAC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CGTCCCTGTGAAGGGGCACCCAGGCCTGACAGCCCCAGACTTG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TTGCCAACCCTCCAG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CCTGCATGGCTAGGACCCAACGCCTAG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TCATCCAGCACTCACCCCAACCAAAGCCATGGGAATTGCTGGGACCCGG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AGGTAGGGGGTGGCACATGTGTGCCCTGTGCTCTGAAGTGCCCCTAC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GCCCTGGAATCCTCCCCGTGTCTCAACACACTACCCTCTGGGGAGTCAG</a:t>
            </a:r>
            <a:br>
              <a:rPr sz="1200"/>
            </a:b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CCCCAGAGTCCCC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TGGGCCTGGAGGGCTGCTTTGGGGCAGG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AACTTTGGCCACCAGGCCTCTGACCTGCACCAGGAGACACTGGGAGGT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GTCCCCAA ACCCGCACAGAGCAGGACTGCAGCCTGAGGAAAGAGCAAG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GAGAGAGGCCTGCGACAAGTGAGGTGAGGGCTTTTGGGGGA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GTCCTGGCGCCTGGAGTGTGGGGGCCTGGCAGGGGCCCTGAACCGGGAC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TGAGGTCCTGTACTTGCTGGCCTGGGGTGGACAGAACCCAAGCCTGGG</a:t>
            </a:r>
            <a:br>
              <a:rPr sz="1200"/>
            </a:b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AAAATCCCCAGGGCCCCCTAAACCCAACAC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GAAGTCACTAGTCC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CTTGAGTTTCTGATGAGGAAGCCTCTCTCC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CC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CC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CCCACCCTG CCATAAAGTAATTTGATCCTCAAGAA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ACCACACCT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TTGGTCCCTGGCTAA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CAAT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AACAGCA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GAAATAGAAA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GAGAAATACACAC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TGAGAAACTGAAAC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AGGGGAAAGGAGG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CTCACTGAGCACCGTCCCAGCATCCGGACACCACAGCGGCCC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CTC</a:t>
            </a:r>
            <a:br>
              <a:rPr sz="1200"/>
            </a:b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CGCAGAAAACCACAC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CAAACC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CTCAACACTTCC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T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CCA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AGCCAGAAG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G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ACAAGGAGGAAC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TextBox 5"/>
          <p:cNvSpPr/>
          <p:nvPr/>
        </p:nvSpPr>
        <p:spPr>
          <a:xfrm>
            <a:off x="1600200" y="52704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9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Box 6"/>
          <p:cNvSpPr/>
          <p:nvPr/>
        </p:nvSpPr>
        <p:spPr>
          <a:xfrm>
            <a:off x="1600200" y="70956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9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TextBox 7"/>
          <p:cNvSpPr/>
          <p:nvPr/>
        </p:nvSpPr>
        <p:spPr>
          <a:xfrm>
            <a:off x="1600200" y="89388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8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TextBox 8"/>
          <p:cNvSpPr/>
          <p:nvPr/>
        </p:nvSpPr>
        <p:spPr>
          <a:xfrm>
            <a:off x="1600200" y="107640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8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TextBox 9"/>
          <p:cNvSpPr/>
          <p:nvPr/>
        </p:nvSpPr>
        <p:spPr>
          <a:xfrm>
            <a:off x="1600200" y="125892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7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TextBox 10"/>
          <p:cNvSpPr/>
          <p:nvPr/>
        </p:nvSpPr>
        <p:spPr>
          <a:xfrm>
            <a:off x="1600200" y="144144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7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TextBox 11"/>
          <p:cNvSpPr/>
          <p:nvPr/>
        </p:nvSpPr>
        <p:spPr>
          <a:xfrm>
            <a:off x="1600200" y="162576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6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TextBox 12"/>
          <p:cNvSpPr/>
          <p:nvPr/>
        </p:nvSpPr>
        <p:spPr>
          <a:xfrm>
            <a:off x="1600200" y="180828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6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Box 13"/>
          <p:cNvSpPr/>
          <p:nvPr/>
        </p:nvSpPr>
        <p:spPr>
          <a:xfrm>
            <a:off x="1600200" y="199080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5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Box 14"/>
          <p:cNvSpPr/>
          <p:nvPr/>
        </p:nvSpPr>
        <p:spPr>
          <a:xfrm>
            <a:off x="1600200" y="217476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5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Box 15"/>
          <p:cNvSpPr/>
          <p:nvPr/>
        </p:nvSpPr>
        <p:spPr>
          <a:xfrm>
            <a:off x="1600200" y="235728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4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Box 16"/>
          <p:cNvSpPr/>
          <p:nvPr/>
        </p:nvSpPr>
        <p:spPr>
          <a:xfrm>
            <a:off x="1600200" y="254016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4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TextBox 17"/>
          <p:cNvSpPr/>
          <p:nvPr/>
        </p:nvSpPr>
        <p:spPr>
          <a:xfrm>
            <a:off x="1600200" y="272268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3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TextBox 18"/>
          <p:cNvSpPr/>
          <p:nvPr/>
        </p:nvSpPr>
        <p:spPr>
          <a:xfrm>
            <a:off x="1600200" y="290664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3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TextBox 19"/>
          <p:cNvSpPr/>
          <p:nvPr/>
        </p:nvSpPr>
        <p:spPr>
          <a:xfrm>
            <a:off x="1600200" y="308916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0"/>
          <p:cNvSpPr/>
          <p:nvPr/>
        </p:nvSpPr>
        <p:spPr>
          <a:xfrm>
            <a:off x="1600200" y="345132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2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21"/>
          <p:cNvSpPr/>
          <p:nvPr/>
        </p:nvSpPr>
        <p:spPr>
          <a:xfrm>
            <a:off x="1600200" y="381636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1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22"/>
          <p:cNvSpPr/>
          <p:nvPr/>
        </p:nvSpPr>
        <p:spPr>
          <a:xfrm>
            <a:off x="1600200" y="399888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1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23"/>
          <p:cNvSpPr/>
          <p:nvPr/>
        </p:nvSpPr>
        <p:spPr>
          <a:xfrm>
            <a:off x="1676520" y="418140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6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TextBox 24"/>
          <p:cNvSpPr/>
          <p:nvPr/>
        </p:nvSpPr>
        <p:spPr>
          <a:xfrm>
            <a:off x="1676520" y="436572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1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TextBox 25"/>
          <p:cNvSpPr/>
          <p:nvPr/>
        </p:nvSpPr>
        <p:spPr>
          <a:xfrm>
            <a:off x="2971800" y="4518000"/>
            <a:ext cx="533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Rectangle 30"/>
          <p:cNvSpPr/>
          <p:nvPr/>
        </p:nvSpPr>
        <p:spPr>
          <a:xfrm>
            <a:off x="5867280" y="3484440"/>
            <a:ext cx="1371600" cy="2304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2" name="Rectangle 32"/>
          <p:cNvSpPr/>
          <p:nvPr/>
        </p:nvSpPr>
        <p:spPr>
          <a:xfrm>
            <a:off x="2054160" y="3809880"/>
            <a:ext cx="308160" cy="22860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Rectangle 36"/>
          <p:cNvSpPr/>
          <p:nvPr/>
        </p:nvSpPr>
        <p:spPr>
          <a:xfrm>
            <a:off x="3733920" y="3809880"/>
            <a:ext cx="990360" cy="25236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TextBox 2"/>
          <p:cNvSpPr/>
          <p:nvPr/>
        </p:nvSpPr>
        <p:spPr>
          <a:xfrm>
            <a:off x="6095880" y="3257640"/>
            <a:ext cx="98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SRE/IRF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TextBox 3"/>
          <p:cNvSpPr/>
          <p:nvPr/>
        </p:nvSpPr>
        <p:spPr>
          <a:xfrm>
            <a:off x="4094280" y="3624120"/>
            <a:ext cx="53316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AS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76" name="Straight Arrow Connector 27"/>
          <p:cNvCxnSpPr/>
          <p:nvPr/>
        </p:nvCxnSpPr>
        <p:spPr>
          <a:xfrm>
            <a:off x="3124080" y="4412880"/>
            <a:ext cx="30240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7" name="TextBox 9"/>
          <p:cNvSpPr/>
          <p:nvPr/>
        </p:nvSpPr>
        <p:spPr>
          <a:xfrm>
            <a:off x="7868160" y="6400800"/>
            <a:ext cx="964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gony et al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08T15:19:27Z</dcterms:created>
  <dc:creator>Windows User</dc:creator>
  <dc:description/>
  <dc:language>en-US</dc:language>
  <cp:lastModifiedBy>Joan Lewis-Wambi</cp:lastModifiedBy>
  <cp:lastPrinted>2015-11-23T20:43:10Z</cp:lastPrinted>
  <dcterms:modified xsi:type="dcterms:W3CDTF">2016-01-31T04:49:31Z</dcterms:modified>
  <cp:revision>196</cp:revision>
  <dc:subject/>
  <dc:title>Supplementary Figures</dc:title>
</cp:coreProperties>
</file>